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8"/>
  </p:notesMasterIdLst>
  <p:sldIdLst>
    <p:sldId id="256" r:id="rId3"/>
    <p:sldId id="259" r:id="rId4"/>
    <p:sldId id="260" r:id="rId5"/>
    <p:sldId id="258" r:id="rId6"/>
    <p:sldId id="261" r:id="rId7"/>
  </p:sldIdLst>
  <p:sldSz cx="12192000" cy="6858000"/>
  <p:notesSz cx="6858000" cy="9144000"/>
  <p:defaultTextStyle>
    <a:defPPr>
      <a:defRPr lang="LID4096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J:\My%20Drive\New%20Research%20with%20Yasser%20Moursi\Germination%20D%20&amp;%20C%20WAS\Manuscirpt%20files\Supplementary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My%20Drive\New%20Research%20with%20Yasser%20Moursi\Germination%20D%20&amp;%20C%20WAS\Manuscirpt%20files\Supplementary%20Tab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627078198760721E-2"/>
          <c:y val="2.361575803832125E-2"/>
          <c:w val="0.91836843182754391"/>
          <c:h val="0.7854735876106318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Table S2'!$Y$2:$Y$23</c:f>
              <c:strCache>
                <c:ptCount val="22"/>
                <c:pt idx="0">
                  <c:v>1A</c:v>
                </c:pt>
                <c:pt idx="1">
                  <c:v>1B</c:v>
                </c:pt>
                <c:pt idx="2">
                  <c:v>1D</c:v>
                </c:pt>
                <c:pt idx="3">
                  <c:v>2A</c:v>
                </c:pt>
                <c:pt idx="4">
                  <c:v>2B</c:v>
                </c:pt>
                <c:pt idx="5">
                  <c:v>2D</c:v>
                </c:pt>
                <c:pt idx="6">
                  <c:v>3A</c:v>
                </c:pt>
                <c:pt idx="7">
                  <c:v>3B</c:v>
                </c:pt>
                <c:pt idx="8">
                  <c:v>3D</c:v>
                </c:pt>
                <c:pt idx="9">
                  <c:v>4A</c:v>
                </c:pt>
                <c:pt idx="10">
                  <c:v>4B</c:v>
                </c:pt>
                <c:pt idx="11">
                  <c:v>4D</c:v>
                </c:pt>
                <c:pt idx="12">
                  <c:v>5A</c:v>
                </c:pt>
                <c:pt idx="13">
                  <c:v>5B</c:v>
                </c:pt>
                <c:pt idx="14">
                  <c:v>5D</c:v>
                </c:pt>
                <c:pt idx="15">
                  <c:v>6A</c:v>
                </c:pt>
                <c:pt idx="16">
                  <c:v>6B</c:v>
                </c:pt>
                <c:pt idx="17">
                  <c:v>6D</c:v>
                </c:pt>
                <c:pt idx="18">
                  <c:v>7A</c:v>
                </c:pt>
                <c:pt idx="19">
                  <c:v>7B</c:v>
                </c:pt>
                <c:pt idx="20">
                  <c:v>7D</c:v>
                </c:pt>
                <c:pt idx="21">
                  <c:v>UN</c:v>
                </c:pt>
              </c:strCache>
            </c:strRef>
          </c:cat>
          <c:val>
            <c:numRef>
              <c:f>'Table S2'!$Z$2:$Z$23</c:f>
              <c:numCache>
                <c:formatCode>General</c:formatCode>
                <c:ptCount val="22"/>
                <c:pt idx="0">
                  <c:v>8</c:v>
                </c:pt>
                <c:pt idx="1">
                  <c:v>13</c:v>
                </c:pt>
                <c:pt idx="2">
                  <c:v>9</c:v>
                </c:pt>
                <c:pt idx="3">
                  <c:v>8</c:v>
                </c:pt>
                <c:pt idx="4">
                  <c:v>10</c:v>
                </c:pt>
                <c:pt idx="5">
                  <c:v>5</c:v>
                </c:pt>
                <c:pt idx="6">
                  <c:v>1</c:v>
                </c:pt>
                <c:pt idx="7">
                  <c:v>5</c:v>
                </c:pt>
                <c:pt idx="8">
                  <c:v>2</c:v>
                </c:pt>
                <c:pt idx="9">
                  <c:v>1</c:v>
                </c:pt>
                <c:pt idx="10">
                  <c:v>2</c:v>
                </c:pt>
                <c:pt idx="11">
                  <c:v>0</c:v>
                </c:pt>
                <c:pt idx="12">
                  <c:v>3</c:v>
                </c:pt>
                <c:pt idx="13">
                  <c:v>13</c:v>
                </c:pt>
                <c:pt idx="14">
                  <c:v>1</c:v>
                </c:pt>
                <c:pt idx="15">
                  <c:v>10</c:v>
                </c:pt>
                <c:pt idx="16">
                  <c:v>10</c:v>
                </c:pt>
                <c:pt idx="17">
                  <c:v>2</c:v>
                </c:pt>
                <c:pt idx="18">
                  <c:v>4</c:v>
                </c:pt>
                <c:pt idx="19">
                  <c:v>12</c:v>
                </c:pt>
                <c:pt idx="20">
                  <c:v>0</c:v>
                </c:pt>
                <c:pt idx="2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5D-425A-91BA-A1330682AAE1}"/>
            </c:ext>
          </c:extLst>
        </c:ser>
        <c:ser>
          <c:idx val="1"/>
          <c:order val="1"/>
          <c:tx>
            <c:v>Drought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Table S2'!$Y$2:$Y$23</c:f>
              <c:strCache>
                <c:ptCount val="22"/>
                <c:pt idx="0">
                  <c:v>1A</c:v>
                </c:pt>
                <c:pt idx="1">
                  <c:v>1B</c:v>
                </c:pt>
                <c:pt idx="2">
                  <c:v>1D</c:v>
                </c:pt>
                <c:pt idx="3">
                  <c:v>2A</c:v>
                </c:pt>
                <c:pt idx="4">
                  <c:v>2B</c:v>
                </c:pt>
                <c:pt idx="5">
                  <c:v>2D</c:v>
                </c:pt>
                <c:pt idx="6">
                  <c:v>3A</c:v>
                </c:pt>
                <c:pt idx="7">
                  <c:v>3B</c:v>
                </c:pt>
                <c:pt idx="8">
                  <c:v>3D</c:v>
                </c:pt>
                <c:pt idx="9">
                  <c:v>4A</c:v>
                </c:pt>
                <c:pt idx="10">
                  <c:v>4B</c:v>
                </c:pt>
                <c:pt idx="11">
                  <c:v>4D</c:v>
                </c:pt>
                <c:pt idx="12">
                  <c:v>5A</c:v>
                </c:pt>
                <c:pt idx="13">
                  <c:v>5B</c:v>
                </c:pt>
                <c:pt idx="14">
                  <c:v>5D</c:v>
                </c:pt>
                <c:pt idx="15">
                  <c:v>6A</c:v>
                </c:pt>
                <c:pt idx="16">
                  <c:v>6B</c:v>
                </c:pt>
                <c:pt idx="17">
                  <c:v>6D</c:v>
                </c:pt>
                <c:pt idx="18">
                  <c:v>7A</c:v>
                </c:pt>
                <c:pt idx="19">
                  <c:v>7B</c:v>
                </c:pt>
                <c:pt idx="20">
                  <c:v>7D</c:v>
                </c:pt>
                <c:pt idx="21">
                  <c:v>UN</c:v>
                </c:pt>
              </c:strCache>
            </c:strRef>
          </c:cat>
          <c:val>
            <c:numRef>
              <c:f>'Table S2'!$AA$2:$AA$23</c:f>
              <c:numCache>
                <c:formatCode>General</c:formatCode>
                <c:ptCount val="22"/>
                <c:pt idx="0">
                  <c:v>6</c:v>
                </c:pt>
                <c:pt idx="1">
                  <c:v>6</c:v>
                </c:pt>
                <c:pt idx="2">
                  <c:v>4</c:v>
                </c:pt>
                <c:pt idx="3">
                  <c:v>7</c:v>
                </c:pt>
                <c:pt idx="4">
                  <c:v>0</c:v>
                </c:pt>
                <c:pt idx="5">
                  <c:v>0</c:v>
                </c:pt>
                <c:pt idx="6">
                  <c:v>2</c:v>
                </c:pt>
                <c:pt idx="7">
                  <c:v>1</c:v>
                </c:pt>
                <c:pt idx="8">
                  <c:v>0</c:v>
                </c:pt>
                <c:pt idx="9">
                  <c:v>6</c:v>
                </c:pt>
                <c:pt idx="10">
                  <c:v>2</c:v>
                </c:pt>
                <c:pt idx="11">
                  <c:v>2</c:v>
                </c:pt>
                <c:pt idx="12">
                  <c:v>37</c:v>
                </c:pt>
                <c:pt idx="13">
                  <c:v>21</c:v>
                </c:pt>
                <c:pt idx="14">
                  <c:v>1</c:v>
                </c:pt>
                <c:pt idx="15">
                  <c:v>3</c:v>
                </c:pt>
                <c:pt idx="16">
                  <c:v>8</c:v>
                </c:pt>
                <c:pt idx="17">
                  <c:v>3</c:v>
                </c:pt>
                <c:pt idx="18">
                  <c:v>2</c:v>
                </c:pt>
                <c:pt idx="19">
                  <c:v>3</c:v>
                </c:pt>
                <c:pt idx="20">
                  <c:v>1</c:v>
                </c:pt>
                <c:pt idx="21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5D-425A-91BA-A1330682AA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744351"/>
        <c:axId val="54761151"/>
      </c:barChart>
      <c:catAx>
        <c:axId val="54744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LID4096"/>
          </a:p>
        </c:txPr>
        <c:crossAx val="54761151"/>
        <c:crosses val="autoZero"/>
        <c:auto val="1"/>
        <c:lblAlgn val="ctr"/>
        <c:lblOffset val="100"/>
        <c:noMultiLvlLbl val="0"/>
      </c:catAx>
      <c:valAx>
        <c:axId val="5476115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LID4096"/>
          </a:p>
        </c:txPr>
        <c:crossAx val="547443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8358382799454651"/>
          <c:y val="2.4148723844319302E-2"/>
          <c:w val="0.12179018209272136"/>
          <c:h val="0.1290065080833547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LID4096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LID4096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Table S2'!$AC$2:$AC$4</c:f>
              <c:strCache>
                <c:ptCount val="3"/>
                <c:pt idx="0">
                  <c:v>A</c:v>
                </c:pt>
                <c:pt idx="1">
                  <c:v>B</c:v>
                </c:pt>
                <c:pt idx="2">
                  <c:v>D</c:v>
                </c:pt>
              </c:strCache>
            </c:strRef>
          </c:cat>
          <c:val>
            <c:numRef>
              <c:f>'Table S2'!$AD$2:$AD$4</c:f>
              <c:numCache>
                <c:formatCode>General</c:formatCode>
                <c:ptCount val="3"/>
                <c:pt idx="0">
                  <c:v>35</c:v>
                </c:pt>
                <c:pt idx="1">
                  <c:v>65</c:v>
                </c:pt>
                <c:pt idx="2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20-4C07-9B5B-4BA6F03F667C}"/>
            </c:ext>
          </c:extLst>
        </c:ser>
        <c:ser>
          <c:idx val="1"/>
          <c:order val="1"/>
          <c:tx>
            <c:v>Drought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Table S2'!$AC$2:$AC$4</c:f>
              <c:strCache>
                <c:ptCount val="3"/>
                <c:pt idx="0">
                  <c:v>A</c:v>
                </c:pt>
                <c:pt idx="1">
                  <c:v>B</c:v>
                </c:pt>
                <c:pt idx="2">
                  <c:v>D</c:v>
                </c:pt>
              </c:strCache>
            </c:strRef>
          </c:cat>
          <c:val>
            <c:numRef>
              <c:f>'Table S2'!$AE$2:$AE$4</c:f>
              <c:numCache>
                <c:formatCode>General</c:formatCode>
                <c:ptCount val="3"/>
                <c:pt idx="0">
                  <c:v>63</c:v>
                </c:pt>
                <c:pt idx="1">
                  <c:v>41</c:v>
                </c:pt>
                <c:pt idx="2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20-4C07-9B5B-4BA6F03F66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7596351"/>
        <c:axId val="157596831"/>
      </c:barChart>
      <c:catAx>
        <c:axId val="157596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LID4096"/>
          </a:p>
        </c:txPr>
        <c:crossAx val="157596831"/>
        <c:crosses val="autoZero"/>
        <c:auto val="1"/>
        <c:lblAlgn val="ctr"/>
        <c:lblOffset val="100"/>
        <c:noMultiLvlLbl val="0"/>
      </c:catAx>
      <c:valAx>
        <c:axId val="1575968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LID4096"/>
          </a:p>
        </c:txPr>
        <c:crossAx val="1575963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5229045501345273"/>
          <c:y val="4.6587558440147989E-2"/>
          <c:w val="0.31360089767636334"/>
          <c:h val="0.130750467838175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LID4096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LID4096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107EE9-B835-4C06-9C69-FF8146D04C99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C75E49-69E5-472C-A534-DE354909A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642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C75E49-69E5-472C-A534-DE354909A2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220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013C2EF-2D68-4D57-AF38-8D1E6A5F4078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054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62C8A-00BF-D0ED-B602-6889E9B760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E7AFD8-07C1-AC83-5249-90B0A1CCA2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4A1F0-F3AC-B872-4DF8-791B4FFE3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AB2ECC-7147-6CB4-FBE2-E93FAF1FC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7AEBC0-9E32-3AC2-CD2B-E4DC3124D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26359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F5DF4-1339-D130-DF1F-EAFBC9D8E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0C9DF4-CA57-2B2A-74A0-83BBFF0E1D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783B4-E42B-F0E7-7D2C-E33970994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781E89-6145-8BE0-296E-E5A0F4A01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AD099A-B85C-7B0E-9A36-7B64ED3BF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2484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98B162-B403-9482-97E1-623900D092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8EBC9-AAB9-8DF4-1CCA-7F946EAC9B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8234AA-6CE7-F3BB-482E-F0E8973AC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66BCF-5E76-B5D3-79A7-178E92FF3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145D0E-E4B1-3FD0-DEB1-6CF91A6FF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069032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CBB0E-EB44-3984-3847-4B3F49F4B3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47312A-E99F-E6D8-7FB8-AD7B977350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508EF-13FE-32BC-E0BC-09ECCA150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0FA7E-6AA7-4AA1-C868-752EB6AFF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8A0A13-51E2-1B9F-92F2-BE74626FC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2562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BE1B9-C201-A0D1-5176-9656FCE600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D1EBED-4315-648E-BC93-58778476F6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541F95-C745-11B1-C95E-11327B2C0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9A8BA-0CB7-8F29-44E8-3D40C61F7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7AC578-82BE-8136-2ED8-78DC18078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1629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FB7A0-79B7-EDBE-98FB-8F2E12ACE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0589CE-8C2A-A329-8BE4-D02197CC31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E022C9-5C39-F444-84AD-3090272FD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88039D-3B76-DAA4-D11E-80B5B2631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19CEC-E5CA-A326-73D3-B0E8B36CC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00374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A8810C-9CB0-453B-0D40-4171AC58B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361FAB-6A73-3B0D-B84E-3BFC76244D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F7ACE9-2D2B-85AC-39F7-665E527CD4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81E471-7C03-38D5-14F1-B8E64F1A4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EDA0AD-71B3-3BDD-45BE-52A09C1A5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8BF9D8-48AB-4DC9-37ED-CAB3A03E9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96429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09A21-32A6-1134-A690-32688468E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8117B5-DD69-44C6-2310-00E5913AD2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A5C962-1EBD-0B0D-FEEF-E57D04B74F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8747AC-03C7-7AE0-7164-004FE74453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414584-3527-BB3B-FC86-430F35E34F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76991D-F0A4-249C-3F41-7CFB407ED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EE00D1-2A62-EAD1-91B5-8557FE398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2C1FD7-96C9-B147-E32D-4AE23DE4A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330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8BADD-4D87-871F-A6AB-53573C84A7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DB218C-1887-D593-9AEC-1D0F555F4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1F185B-DA8B-5EA6-C88A-4C373DF20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D0CD7B-1A89-2234-4B10-D7E392562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7323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4EDE70-A132-F4C3-244B-9798779FD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A8ECB3-F07E-AF35-BDF9-F52E0637A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F65A01-F77F-CC69-1B25-ABE7ABFF9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44102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304EF-9370-3C46-47EF-C92A2C23EB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9DC4A-AB61-725C-D0FB-3882F2B1BF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AA1EC8-86C8-15D0-B097-AA36EF39FF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DC74B4-4B07-91DA-171F-B3ABD3DED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48A4BB-1DED-91AA-7FFB-5DEC83411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08DCFC-ACA0-D3ED-6EA0-31432A904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971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98C2E-1927-12DC-8B00-D7C0B5857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052AB5-F539-82A9-6BF9-9548784384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29CBAC-713A-0A42-61DC-B888C8497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44A938-8CE1-8AF9-2260-4E08F1D11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3CA8F-0E0A-46F2-28F0-502E647EF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0903679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5E9FD-FA21-0D70-D0D9-2EC40662BC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A2B552-896D-F4B2-B387-F27821A113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04AF47-2E24-3CFE-6367-31A3C527D1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8A9E06-8D9A-B7FA-DB5C-5CFD77D0F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0C6157-2F53-A5A4-5265-1601BB183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38FBBF-4654-A4C9-DA88-A20327195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34351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7035A-0C95-F004-ECA4-CB7940341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9DD0C6-AF43-DC0A-8ABB-74BCB8BBEA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1D10E-36DA-B8A8-27AC-7375CC2DA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577E5E-D8E2-AC34-CF8A-647C334C2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9D07B-7F7F-79E9-F808-97A940DA0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88453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C7638A-87CF-24B4-B7F2-F3DF86952E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45C24-7124-B3F2-E86B-893CEC5DE5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BA6FD-4968-BFF0-EF64-1C9A4EDB5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6B47C9-21A9-1B97-6B47-447369B96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752BE-349E-AB4C-FEBA-313865850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393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D5BF6-D50A-252E-F9A3-9D159912B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E8628D-E0B9-EB74-8C8F-60648020D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39F1EA-E575-D02D-5232-9B96988C0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354F35-56FE-FA7C-F20A-F8C0D700D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909B9B-60DA-30E6-7D4A-B2242242D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836612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B8A3F-3422-684D-D83C-1BDA7E483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F218D9-BD8F-2AFC-4F33-4B49F312FA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D3E847-7EEB-A61E-69B9-621BAA4A1A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A04DA6-F50D-739A-D9D7-C8885C16E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F49D3-11D0-BC1B-B904-C717F1B8D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90FC2-6FD3-9BB6-0029-97CB05086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164534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A8A5D5-F0F2-D174-0470-9A6829D6D3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6C403E-2F17-5220-D776-2E35BC74F6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C64A11-F176-EACB-12C2-7BBE5DA9E5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73FF3E-B568-ADA6-DAEC-AE845BF953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FB26DA-02A9-8D26-BD72-5E0710311D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A11F13-2943-766E-EE3E-FDCA79C34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727405-BA37-5388-2C4B-71FB0EFFC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7418B1-A7D5-32B7-31CC-8B35EB46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304135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0FB3D-D3C4-DB8F-584D-27B9B0D12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C4BE90-BD73-DE19-EBD9-ADF9642C7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5767DF-57D7-A368-0D96-768A7635D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ADCFBF-22AE-C11C-9237-AF57856F9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139041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F16573-BF06-D21E-1C35-1E612B20C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D6F52D-AD59-17DC-EEFB-11C32E80C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7B357F-B900-8A7D-B213-5C6599E52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702999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8F3EF-B504-126D-6470-5E33D43FE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8BC8B8-47B9-E9EC-75F6-0930FAD510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918996-7DA7-D500-6553-BA742D0E25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341CC7-E7A1-DEA9-E435-046508434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4F3B52-F848-47C4-2E9E-2505CF6A8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A243F3-B02C-19EB-75A3-242E60A1E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705268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F0C95-0D6C-CD7A-090B-B7512A007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73CFF5-9EA6-595B-B013-597C2F6545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C75B95-B3B0-9B2C-4802-973A4AEF62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3E0C78-567D-1488-3349-0E7DC0689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D9ED02-7609-EEC4-0335-2F8BF5111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2CEB7A-94D9-9420-4E09-570E4B7F6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0564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FFD01E-5F86-0547-850D-A585259FA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1F9E28-4032-FED1-80D8-27464FAA8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938060-E096-F085-2082-54B6CC7C8D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6DADE3-C37E-4324-A9DF-B795362D4985}" type="datetimeFigureOut">
              <a:rPr lang="LID4096" smtClean="0"/>
              <a:t>09/27/2025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16DC5F-19FB-791D-87F9-F21E5866CC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93056-F39D-6831-D147-9514911F28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79C7EC-9C44-47FB-A995-E5C66545BC99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917066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ID4096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D0B9426-6CE6-2ED7-0FF2-734FA760B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9AA865-6B2A-F3E4-4F88-8C2008FA1D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1CB118-8B31-D2FA-053D-B3215D5073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5329230-046F-427D-8B8C-A1071D565622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C1474-9F6B-FE34-00C6-A6052C97FC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3A273A-5D25-08E0-09E2-6C79B1508C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127A6F-5C41-45FA-98B3-B07D05E17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8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6.jpg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EBF425E-C11F-A91D-6459-1A22D5E8C5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8491111"/>
              </p:ext>
            </p:extLst>
          </p:nvPr>
        </p:nvGraphicFramePr>
        <p:xfrm>
          <a:off x="137653" y="191637"/>
          <a:ext cx="8327922" cy="4169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B480E51-42D0-4F5D-385D-E95351FFCC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605182"/>
              </p:ext>
            </p:extLst>
          </p:nvPr>
        </p:nvGraphicFramePr>
        <p:xfrm>
          <a:off x="8584054" y="247025"/>
          <a:ext cx="3470293" cy="4169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D32D225-0578-5D88-B9F1-8D929A7AD757}"/>
              </a:ext>
            </a:extLst>
          </p:cNvPr>
          <p:cNvSpPr txBox="1"/>
          <p:nvPr/>
        </p:nvSpPr>
        <p:spPr>
          <a:xfrm>
            <a:off x="642257" y="0"/>
            <a:ext cx="348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FAAEFE0-6731-FBA5-CFF1-11E32B024FCF}"/>
              </a:ext>
            </a:extLst>
          </p:cNvPr>
          <p:cNvSpPr txBox="1"/>
          <p:nvPr/>
        </p:nvSpPr>
        <p:spPr>
          <a:xfrm>
            <a:off x="9068150" y="27568"/>
            <a:ext cx="348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3EA665-14B2-6B77-C8D7-E52CA74F0518}"/>
              </a:ext>
            </a:extLst>
          </p:cNvPr>
          <p:cNvSpPr txBox="1"/>
          <p:nvPr/>
        </p:nvSpPr>
        <p:spPr>
          <a:xfrm>
            <a:off x="407406" y="4943192"/>
            <a:ext cx="113620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.</a:t>
            </a:r>
            <a:r>
              <a:rPr lang="en-US" dirty="0"/>
              <a:t> (a) Number of significant SNPs detected on each chromosome under control and drought stress conditions. (b) Distribution of significant SNPs across genomes under control and drought stress conditions.</a:t>
            </a:r>
          </a:p>
        </p:txBody>
      </p:sp>
    </p:spTree>
    <p:extLst>
      <p:ext uri="{BB962C8B-B14F-4D97-AF65-F5344CB8AC3E}">
        <p14:creationId xmlns:p14="http://schemas.microsoft.com/office/powerpoint/2010/main" val="284073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graph showing the growth of a farm&#10;&#10;AI-generated content may be incorrect.">
            <a:extLst>
              <a:ext uri="{FF2B5EF4-FFF2-40B4-BE49-F238E27FC236}">
                <a16:creationId xmlns:a16="http://schemas.microsoft.com/office/drawing/2014/main" id="{42303938-110B-0A2A-704C-5ABCAED936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63" y="0"/>
            <a:ext cx="2384833" cy="2384833"/>
          </a:xfrm>
          <a:prstGeom prst="rect">
            <a:avLst/>
          </a:prstGeom>
        </p:spPr>
      </p:pic>
      <p:pic>
        <p:nvPicPr>
          <p:cNvPr id="7" name="Picture 6" descr="A graph of a graph with a red line&#10;&#10;AI-generated content may be incorrect.">
            <a:extLst>
              <a:ext uri="{FF2B5EF4-FFF2-40B4-BE49-F238E27FC236}">
                <a16:creationId xmlns:a16="http://schemas.microsoft.com/office/drawing/2014/main" id="{0704932D-4BE8-F600-122B-3A4A4DA783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1212" y="0"/>
            <a:ext cx="2384833" cy="2384833"/>
          </a:xfrm>
          <a:prstGeom prst="rect">
            <a:avLst/>
          </a:prstGeom>
        </p:spPr>
      </p:pic>
      <p:pic>
        <p:nvPicPr>
          <p:cNvPr id="9" name="Picture 8" descr="A graph of a graph showing a growth curve&#10;&#10;AI-generated content may be incorrect.">
            <a:extLst>
              <a:ext uri="{FF2B5EF4-FFF2-40B4-BE49-F238E27FC236}">
                <a16:creationId xmlns:a16="http://schemas.microsoft.com/office/drawing/2014/main" id="{9234C593-6EC1-AD30-BF9A-3E91EEB76E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1346" y="0"/>
            <a:ext cx="2384833" cy="2384833"/>
          </a:xfrm>
          <a:prstGeom prst="rect">
            <a:avLst/>
          </a:prstGeom>
        </p:spPr>
      </p:pic>
      <p:pic>
        <p:nvPicPr>
          <p:cNvPr id="11" name="Picture 10" descr="A graph of a graph showing a growth curve&#10;&#10;AI-generated content may be incorrect.">
            <a:extLst>
              <a:ext uri="{FF2B5EF4-FFF2-40B4-BE49-F238E27FC236}">
                <a16:creationId xmlns:a16="http://schemas.microsoft.com/office/drawing/2014/main" id="{85E5AEA5-A964-B2BB-EFAB-11AAC163D14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957" y="0"/>
            <a:ext cx="2384833" cy="2384833"/>
          </a:xfrm>
          <a:prstGeom prst="rect">
            <a:avLst/>
          </a:prstGeom>
        </p:spPr>
      </p:pic>
      <p:pic>
        <p:nvPicPr>
          <p:cNvPr id="13" name="Picture 12" descr="A graph of a graph with a line&#10;&#10;AI-generated content may be incorrect.">
            <a:extLst>
              <a:ext uri="{FF2B5EF4-FFF2-40B4-BE49-F238E27FC236}">
                <a16:creationId xmlns:a16="http://schemas.microsoft.com/office/drawing/2014/main" id="{B785BC3C-EAE0-1304-E1AB-6AA89FB759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0404" y="-1"/>
            <a:ext cx="2384833" cy="2384833"/>
          </a:xfrm>
          <a:prstGeom prst="rect">
            <a:avLst/>
          </a:prstGeom>
        </p:spPr>
      </p:pic>
      <p:pic>
        <p:nvPicPr>
          <p:cNvPr id="15" name="Picture 14" descr="A graph of a graph showing a growth curve&#10;&#10;AI-generated content may be incorrect.">
            <a:extLst>
              <a:ext uri="{FF2B5EF4-FFF2-40B4-BE49-F238E27FC236}">
                <a16:creationId xmlns:a16="http://schemas.microsoft.com/office/drawing/2014/main" id="{B41F9A54-2950-118C-4160-7EF56F9DE5F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5" y="2480649"/>
            <a:ext cx="2384833" cy="238483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5DA6C1A-FC81-8BDA-755D-5E7507982AA3}"/>
              </a:ext>
            </a:extLst>
          </p:cNvPr>
          <p:cNvSpPr txBox="1"/>
          <p:nvPr/>
        </p:nvSpPr>
        <p:spPr>
          <a:xfrm>
            <a:off x="86763" y="5232903"/>
            <a:ext cx="11362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.</a:t>
            </a:r>
            <a:r>
              <a:rPr lang="en-US" dirty="0"/>
              <a:t> QQ plots for all traits evaluated under control conditions.</a:t>
            </a:r>
          </a:p>
        </p:txBody>
      </p:sp>
    </p:spTree>
    <p:extLst>
      <p:ext uri="{BB962C8B-B14F-4D97-AF65-F5344CB8AC3E}">
        <p14:creationId xmlns:p14="http://schemas.microsoft.com/office/powerpoint/2010/main" val="806479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graph of a graph&#10;&#10;AI-generated content may be incorrect.">
            <a:extLst>
              <a:ext uri="{FF2B5EF4-FFF2-40B4-BE49-F238E27FC236}">
                <a16:creationId xmlns:a16="http://schemas.microsoft.com/office/drawing/2014/main" id="{75258284-D79A-D341-2602-99985C8334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81" y="0"/>
            <a:ext cx="2520635" cy="2520635"/>
          </a:xfrm>
          <a:prstGeom prst="rect">
            <a:avLst/>
          </a:prstGeom>
        </p:spPr>
      </p:pic>
      <p:pic>
        <p:nvPicPr>
          <p:cNvPr id="9" name="Picture 8" descr="A graph of a graph showing the growth of a farm&#10;&#10;AI-generated content may be incorrect.">
            <a:extLst>
              <a:ext uri="{FF2B5EF4-FFF2-40B4-BE49-F238E27FC236}">
                <a16:creationId xmlns:a16="http://schemas.microsoft.com/office/drawing/2014/main" id="{C5919FC9-5BDF-5798-3F58-C2ABA8BE4E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9153" y="0"/>
            <a:ext cx="2520635" cy="2520635"/>
          </a:xfrm>
          <a:prstGeom prst="rect">
            <a:avLst/>
          </a:prstGeom>
        </p:spPr>
      </p:pic>
      <p:pic>
        <p:nvPicPr>
          <p:cNvPr id="11" name="Picture 10" descr="A graph of a graph showing the growth of a farm&#10;&#10;AI-generated content may be incorrect.">
            <a:extLst>
              <a:ext uri="{FF2B5EF4-FFF2-40B4-BE49-F238E27FC236}">
                <a16:creationId xmlns:a16="http://schemas.microsoft.com/office/drawing/2014/main" id="{17D2B579-3B19-5AA5-FB2E-79A1745E93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6825" y="-1"/>
            <a:ext cx="2520635" cy="2520635"/>
          </a:xfrm>
          <a:prstGeom prst="rect">
            <a:avLst/>
          </a:prstGeom>
        </p:spPr>
      </p:pic>
      <p:pic>
        <p:nvPicPr>
          <p:cNvPr id="13" name="Picture 12" descr="A graph of a graph with a red line&#10;&#10;AI-generated content may be incorrect.">
            <a:extLst>
              <a:ext uri="{FF2B5EF4-FFF2-40B4-BE49-F238E27FC236}">
                <a16:creationId xmlns:a16="http://schemas.microsoft.com/office/drawing/2014/main" id="{A6FB0F71-D533-2422-B051-00B96B1CB4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4892" y="0"/>
            <a:ext cx="2580240" cy="2580240"/>
          </a:xfrm>
          <a:prstGeom prst="rect">
            <a:avLst/>
          </a:prstGeom>
        </p:spPr>
      </p:pic>
      <p:pic>
        <p:nvPicPr>
          <p:cNvPr id="15" name="Picture 14" descr="A graph of a graph showing the growth of a farm&#10;&#10;AI-generated content may be incorrect.">
            <a:extLst>
              <a:ext uri="{FF2B5EF4-FFF2-40B4-BE49-F238E27FC236}">
                <a16:creationId xmlns:a16="http://schemas.microsoft.com/office/drawing/2014/main" id="{68A3FE29-4207-2EC6-D1DC-A85339454B6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5526" y="-1"/>
            <a:ext cx="2520635" cy="2520635"/>
          </a:xfrm>
          <a:prstGeom prst="rect">
            <a:avLst/>
          </a:prstGeom>
        </p:spPr>
      </p:pic>
      <p:pic>
        <p:nvPicPr>
          <p:cNvPr id="19" name="Picture 18" descr="A graph of a graph with a red line&#10;&#10;AI-generated content may be incorrect.">
            <a:extLst>
              <a:ext uri="{FF2B5EF4-FFF2-40B4-BE49-F238E27FC236}">
                <a16:creationId xmlns:a16="http://schemas.microsoft.com/office/drawing/2014/main" id="{C0769540-A2CA-9CA3-EDD0-09212A362B4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81" y="2761307"/>
            <a:ext cx="2514600" cy="25146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CE129F2-8220-7193-283B-F74F6A46D929}"/>
              </a:ext>
            </a:extLst>
          </p:cNvPr>
          <p:cNvSpPr txBox="1"/>
          <p:nvPr/>
        </p:nvSpPr>
        <p:spPr>
          <a:xfrm>
            <a:off x="81481" y="5550530"/>
            <a:ext cx="11362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.</a:t>
            </a:r>
            <a:r>
              <a:rPr lang="en-US" dirty="0"/>
              <a:t> QQ plots for all traits evaluated under drought  conditions.</a:t>
            </a:r>
          </a:p>
        </p:txBody>
      </p:sp>
    </p:spTree>
    <p:extLst>
      <p:ext uri="{BB962C8B-B14F-4D97-AF65-F5344CB8AC3E}">
        <p14:creationId xmlns:p14="http://schemas.microsoft.com/office/powerpoint/2010/main" val="3472349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id="{39FD6FDF-3706-D5E6-8F29-3F9CC8ECF0D0}"/>
              </a:ext>
            </a:extLst>
          </p:cNvPr>
          <p:cNvGrpSpPr/>
          <p:nvPr/>
        </p:nvGrpSpPr>
        <p:grpSpPr>
          <a:xfrm>
            <a:off x="55235" y="-73878"/>
            <a:ext cx="4109407" cy="2224882"/>
            <a:chOff x="55236" y="-73878"/>
            <a:chExt cx="4049486" cy="2224882"/>
          </a:xfrm>
        </p:grpSpPr>
        <p:pic>
          <p:nvPicPr>
            <p:cNvPr id="36" name="Picture 35" descr="A diagram of a diagram&#10;&#10;AI-generated content may be incorrect.">
              <a:extLst>
                <a:ext uri="{FF2B5EF4-FFF2-40B4-BE49-F238E27FC236}">
                  <a16:creationId xmlns:a16="http://schemas.microsoft.com/office/drawing/2014/main" id="{CE2130E8-8087-C080-0CCE-64336B786C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81" t="6322" r="17501" b="36875"/>
            <a:stretch>
              <a:fillRect/>
            </a:stretch>
          </p:blipFill>
          <p:spPr>
            <a:xfrm>
              <a:off x="55236" y="219161"/>
              <a:ext cx="4049486" cy="1931843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2F876C2-D446-2847-0FA1-D50935C9422A}"/>
                </a:ext>
              </a:extLst>
            </p:cNvPr>
            <p:cNvSpPr txBox="1"/>
            <p:nvPr/>
          </p:nvSpPr>
          <p:spPr>
            <a:xfrm>
              <a:off x="870858" y="-73878"/>
              <a:ext cx="2656114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1D02G0722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129132A9-1C94-81B5-1D4F-97F6258579C8}"/>
              </a:ext>
            </a:extLst>
          </p:cNvPr>
          <p:cNvGrpSpPr/>
          <p:nvPr/>
        </p:nvGrpSpPr>
        <p:grpSpPr>
          <a:xfrm>
            <a:off x="4487447" y="-54943"/>
            <a:ext cx="3732774" cy="2219758"/>
            <a:chOff x="4487447" y="-54943"/>
            <a:chExt cx="3197867" cy="2219758"/>
          </a:xfrm>
        </p:grpSpPr>
        <p:pic>
          <p:nvPicPr>
            <p:cNvPr id="7" name="Picture 6" descr="A diagram of metal activity&#10;&#10;AI-generated content may be incorrect.">
              <a:extLst>
                <a:ext uri="{FF2B5EF4-FFF2-40B4-BE49-F238E27FC236}">
                  <a16:creationId xmlns:a16="http://schemas.microsoft.com/office/drawing/2014/main" id="{0BBEC81F-B54C-0DAE-2A2C-E27B41915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18"/>
            <a:stretch>
              <a:fillRect/>
            </a:stretch>
          </p:blipFill>
          <p:spPr>
            <a:xfrm>
              <a:off x="4487447" y="264676"/>
              <a:ext cx="3066320" cy="1900139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F291E69-240A-6C19-733D-A9FF231A601B}"/>
                </a:ext>
              </a:extLst>
            </p:cNvPr>
            <p:cNvSpPr txBox="1"/>
            <p:nvPr/>
          </p:nvSpPr>
          <p:spPr>
            <a:xfrm>
              <a:off x="4805071" y="-54943"/>
              <a:ext cx="288024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1D02G0744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BC3F9C07-8E61-8298-DFF5-AC04C2963DD5}"/>
              </a:ext>
            </a:extLst>
          </p:cNvPr>
          <p:cNvGrpSpPr/>
          <p:nvPr/>
        </p:nvGrpSpPr>
        <p:grpSpPr>
          <a:xfrm>
            <a:off x="8418857" y="-64707"/>
            <a:ext cx="3753853" cy="2184008"/>
            <a:chOff x="8341909" y="-64707"/>
            <a:chExt cx="3199431" cy="2184008"/>
          </a:xfrm>
        </p:grpSpPr>
        <p:pic>
          <p:nvPicPr>
            <p:cNvPr id="9" name="Picture 8" descr="A diagram of a plant growth&#10;&#10;AI-generated content may be incorrect.">
              <a:extLst>
                <a:ext uri="{FF2B5EF4-FFF2-40B4-BE49-F238E27FC236}">
                  <a16:creationId xmlns:a16="http://schemas.microsoft.com/office/drawing/2014/main" id="{E8AE693E-6AF1-F8E3-8146-4F9BD46A6E3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64"/>
            <a:stretch>
              <a:fillRect/>
            </a:stretch>
          </p:blipFill>
          <p:spPr>
            <a:xfrm>
              <a:off x="8341909" y="219162"/>
              <a:ext cx="3199431" cy="1900139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B1A7F48-8572-3617-7A5E-251DFD522EB1}"/>
                </a:ext>
              </a:extLst>
            </p:cNvPr>
            <p:cNvSpPr txBox="1"/>
            <p:nvPr/>
          </p:nvSpPr>
          <p:spPr>
            <a:xfrm>
              <a:off x="8665030" y="-64707"/>
              <a:ext cx="248194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1B02G2988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0886F612-5BA4-AFB1-3B1B-955C89D6E13C}"/>
              </a:ext>
            </a:extLst>
          </p:cNvPr>
          <p:cNvGrpSpPr/>
          <p:nvPr/>
        </p:nvGrpSpPr>
        <p:grpSpPr>
          <a:xfrm>
            <a:off x="65716" y="2064871"/>
            <a:ext cx="4069544" cy="2317987"/>
            <a:chOff x="65716" y="2064871"/>
            <a:chExt cx="3797656" cy="2317987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71BB97E-1E19-ECCA-852B-9348D14E175B}"/>
                </a:ext>
              </a:extLst>
            </p:cNvPr>
            <p:cNvSpPr txBox="1"/>
            <p:nvPr/>
          </p:nvSpPr>
          <p:spPr>
            <a:xfrm>
              <a:off x="876742" y="2064871"/>
              <a:ext cx="2362555" cy="3202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6B02G2600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5" name="Picture 4" descr="A diagram of a network&#10;&#10;AI-generated content may be incorrect.">
              <a:extLst>
                <a:ext uri="{FF2B5EF4-FFF2-40B4-BE49-F238E27FC236}">
                  <a16:creationId xmlns:a16="http://schemas.microsoft.com/office/drawing/2014/main" id="{96FC00EA-A380-02E8-2183-E995ECD5EE4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" t="404" r="712"/>
            <a:stretch>
              <a:fillRect/>
            </a:stretch>
          </p:blipFill>
          <p:spPr>
            <a:xfrm>
              <a:off x="65716" y="2336464"/>
              <a:ext cx="3797656" cy="2046394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00B8A9E-1D47-0F09-BEBE-31EE7F9DF7C0}"/>
              </a:ext>
            </a:extLst>
          </p:cNvPr>
          <p:cNvSpPr txBox="1"/>
          <p:nvPr/>
        </p:nvSpPr>
        <p:spPr>
          <a:xfrm>
            <a:off x="81481" y="5550530"/>
            <a:ext cx="113620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.</a:t>
            </a:r>
            <a:r>
              <a:rPr lang="en-US" dirty="0"/>
              <a:t> Gene network analysis of the nine common genes detected under both drought and control conditions. Gene networks were obtained from the </a:t>
            </a:r>
            <a:r>
              <a:rPr lang="en-US" dirty="0" err="1"/>
              <a:t>KnetMiner</a:t>
            </a:r>
            <a:r>
              <a:rPr lang="en-US" dirty="0"/>
              <a:t> database.</a:t>
            </a:r>
          </a:p>
        </p:txBody>
      </p:sp>
    </p:spTree>
    <p:extLst>
      <p:ext uri="{BB962C8B-B14F-4D97-AF65-F5344CB8AC3E}">
        <p14:creationId xmlns:p14="http://schemas.microsoft.com/office/powerpoint/2010/main" val="4110023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>
            <a:extLst>
              <a:ext uri="{FF2B5EF4-FFF2-40B4-BE49-F238E27FC236}">
                <a16:creationId xmlns:a16="http://schemas.microsoft.com/office/drawing/2014/main" id="{319DE4BF-7A45-3A64-88A7-573EFD7DFA17}"/>
              </a:ext>
            </a:extLst>
          </p:cNvPr>
          <p:cNvGrpSpPr/>
          <p:nvPr/>
        </p:nvGrpSpPr>
        <p:grpSpPr>
          <a:xfrm>
            <a:off x="163878" y="0"/>
            <a:ext cx="3664836" cy="2231854"/>
            <a:chOff x="4343401" y="2151004"/>
            <a:chExt cx="3808882" cy="2357766"/>
          </a:xfrm>
        </p:grpSpPr>
        <p:pic>
          <p:nvPicPr>
            <p:cNvPr id="17" name="Picture 16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B68EC0FA-F90E-4537-4961-306AB9B277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61" t="3933" b="35063"/>
            <a:stretch>
              <a:fillRect/>
            </a:stretch>
          </p:blipFill>
          <p:spPr>
            <a:xfrm>
              <a:off x="4343401" y="2403172"/>
              <a:ext cx="3808882" cy="2105598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1C81919-E940-596F-5E86-032E69125D0D}"/>
                </a:ext>
              </a:extLst>
            </p:cNvPr>
            <p:cNvSpPr txBox="1"/>
            <p:nvPr/>
          </p:nvSpPr>
          <p:spPr>
            <a:xfrm>
              <a:off x="5403714" y="2151004"/>
              <a:ext cx="2324099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1A02G0365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1E2AFE4-9D3B-980F-35BF-06324AC951C3}"/>
              </a:ext>
            </a:extLst>
          </p:cNvPr>
          <p:cNvGrpSpPr/>
          <p:nvPr/>
        </p:nvGrpSpPr>
        <p:grpSpPr>
          <a:xfrm>
            <a:off x="208243" y="2465680"/>
            <a:ext cx="4049486" cy="2461351"/>
            <a:chOff x="213021" y="3959048"/>
            <a:chExt cx="4022892" cy="2445281"/>
          </a:xfrm>
        </p:grpSpPr>
        <p:pic>
          <p:nvPicPr>
            <p:cNvPr id="34" name="Picture 33" descr="A diagram of a metal structure&#10;&#10;AI-generated content may be incorrect.">
              <a:extLst>
                <a:ext uri="{FF2B5EF4-FFF2-40B4-BE49-F238E27FC236}">
                  <a16:creationId xmlns:a16="http://schemas.microsoft.com/office/drawing/2014/main" id="{F69462F3-2383-103E-ED21-AA9D83F68B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756"/>
            <a:stretch>
              <a:fillRect/>
            </a:stretch>
          </p:blipFill>
          <p:spPr>
            <a:xfrm>
              <a:off x="213021" y="4192430"/>
              <a:ext cx="4022892" cy="221189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5750808-58A0-8D99-524A-B29CB53A5A33}"/>
                </a:ext>
              </a:extLst>
            </p:cNvPr>
            <p:cNvSpPr txBox="1"/>
            <p:nvPr/>
          </p:nvSpPr>
          <p:spPr>
            <a:xfrm>
              <a:off x="1249655" y="3959048"/>
              <a:ext cx="232410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6B02G2594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FCB9D691-31A1-CB03-29A3-23EFE1F93005}"/>
              </a:ext>
            </a:extLst>
          </p:cNvPr>
          <p:cNvGrpSpPr/>
          <p:nvPr/>
        </p:nvGrpSpPr>
        <p:grpSpPr>
          <a:xfrm>
            <a:off x="8363288" y="-47074"/>
            <a:ext cx="3731642" cy="2398289"/>
            <a:chOff x="8112960" y="4437939"/>
            <a:chExt cx="3731642" cy="2398289"/>
          </a:xfrm>
        </p:grpSpPr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FA0C1A8C-88B5-1AB1-B28E-F98F0C12A7E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12960" y="4702145"/>
              <a:ext cx="3731642" cy="2134083"/>
            </a:xfrm>
            <a:prstGeom prst="rect">
              <a:avLst/>
            </a:prstGeom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9AA645F-C6A2-3186-6BBE-00BCCCB4D5DC}"/>
                </a:ext>
              </a:extLst>
            </p:cNvPr>
            <p:cNvSpPr txBox="1"/>
            <p:nvPr/>
          </p:nvSpPr>
          <p:spPr>
            <a:xfrm>
              <a:off x="8721752" y="4437939"/>
              <a:ext cx="2425221" cy="3424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6B02G2591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AF19AEBF-7EEA-1467-58AE-4C03172ECDFD}"/>
              </a:ext>
            </a:extLst>
          </p:cNvPr>
          <p:cNvGrpSpPr/>
          <p:nvPr/>
        </p:nvGrpSpPr>
        <p:grpSpPr>
          <a:xfrm>
            <a:off x="4590316" y="2473511"/>
            <a:ext cx="3605607" cy="2453520"/>
            <a:chOff x="4271069" y="4370085"/>
            <a:chExt cx="3605607" cy="2453520"/>
          </a:xfrm>
        </p:grpSpPr>
        <p:pic>
          <p:nvPicPr>
            <p:cNvPr id="15" name="Picture 14" descr="A diagram of a plant&#10;&#10;AI-generated content may be incorrect.">
              <a:extLst>
                <a:ext uri="{FF2B5EF4-FFF2-40B4-BE49-F238E27FC236}">
                  <a16:creationId xmlns:a16="http://schemas.microsoft.com/office/drawing/2014/main" id="{18485736-C023-9580-3725-E3C24C45022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09"/>
            <a:stretch>
              <a:fillRect/>
            </a:stretch>
          </p:blipFill>
          <p:spPr>
            <a:xfrm>
              <a:off x="4271069" y="4668063"/>
              <a:ext cx="3605607" cy="2155542"/>
            </a:xfrm>
            <a:prstGeom prst="rect">
              <a:avLst/>
            </a:prstGeom>
          </p:spPr>
        </p:pic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9439A2B-3A90-AB4C-85CB-A08F36B98FF4}"/>
                </a:ext>
              </a:extLst>
            </p:cNvPr>
            <p:cNvSpPr txBox="1"/>
            <p:nvPr/>
          </p:nvSpPr>
          <p:spPr>
            <a:xfrm>
              <a:off x="4737877" y="4370085"/>
              <a:ext cx="265339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Calibri" panose="020F0502020204030204" pitchFamily="34" charset="0"/>
                  <a:cs typeface="+mn-cs"/>
                </a:rPr>
                <a:t>TRAESCS4A02G07140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0152A7B-74E8-C307-E6C7-0DAE316C5146}"/>
              </a:ext>
            </a:extLst>
          </p:cNvPr>
          <p:cNvGrpSpPr/>
          <p:nvPr/>
        </p:nvGrpSpPr>
        <p:grpSpPr>
          <a:xfrm>
            <a:off x="4095288" y="-47074"/>
            <a:ext cx="3731642" cy="2277815"/>
            <a:chOff x="8418856" y="2103930"/>
            <a:chExt cx="3773143" cy="2622614"/>
          </a:xfrm>
        </p:grpSpPr>
        <p:pic>
          <p:nvPicPr>
            <p:cNvPr id="10" name="Picture 9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2BF67D14-36AC-857B-7AE3-DB92F4B043E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35" t="6187" r="3353" b="37187"/>
            <a:stretch>
              <a:fillRect/>
            </a:stretch>
          </p:blipFill>
          <p:spPr>
            <a:xfrm>
              <a:off x="8418856" y="2383449"/>
              <a:ext cx="3773143" cy="234309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EA55C2F-5E6F-70FF-CA45-B17D894F7AB2}"/>
                </a:ext>
              </a:extLst>
            </p:cNvPr>
            <p:cNvSpPr txBox="1"/>
            <p:nvPr/>
          </p:nvSpPr>
          <p:spPr>
            <a:xfrm>
              <a:off x="9524684" y="2103930"/>
              <a:ext cx="213904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i="1" dirty="0">
                  <a:solidFill>
                    <a:prstClr val="black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TraesCS1D02G053300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B45DCED-1E65-802E-CBDF-C85419F6DFDB}"/>
              </a:ext>
            </a:extLst>
          </p:cNvPr>
          <p:cNvSpPr txBox="1"/>
          <p:nvPr/>
        </p:nvSpPr>
        <p:spPr>
          <a:xfrm>
            <a:off x="81481" y="5550530"/>
            <a:ext cx="113620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ontinued Supplementary Figure 4.</a:t>
            </a:r>
            <a:r>
              <a:rPr lang="en-US" dirty="0"/>
              <a:t> Gene network analysis of the nine common genes detected under both drought and control conditions. Gene networks were obtained from the </a:t>
            </a:r>
            <a:r>
              <a:rPr lang="en-US" dirty="0" err="1"/>
              <a:t>KnetMiner</a:t>
            </a:r>
            <a:r>
              <a:rPr lang="en-US" dirty="0"/>
              <a:t> database.</a:t>
            </a:r>
          </a:p>
        </p:txBody>
      </p:sp>
    </p:spTree>
    <p:extLst>
      <p:ext uri="{BB962C8B-B14F-4D97-AF65-F5344CB8AC3E}">
        <p14:creationId xmlns:p14="http://schemas.microsoft.com/office/powerpoint/2010/main" val="2885439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38</Words>
  <Application>Microsoft Office PowerPoint</Application>
  <PresentationFormat>Widescreen</PresentationFormat>
  <Paragraphs>18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hmed Sallam</dc:creator>
  <cp:lastModifiedBy>ياسر شعبان سيد مرسى</cp:lastModifiedBy>
  <cp:revision>16</cp:revision>
  <dcterms:created xsi:type="dcterms:W3CDTF">2025-08-09T16:44:15Z</dcterms:created>
  <dcterms:modified xsi:type="dcterms:W3CDTF">2025-09-27T13:12:51Z</dcterms:modified>
</cp:coreProperties>
</file>